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drawings/drawing1.xml" ContentType="application/vnd.openxmlformats-officedocument.drawingml.chartshapes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1" r:id="rId3"/>
    <p:sldId id="262" r:id="rId4"/>
    <p:sldId id="263" r:id="rId5"/>
    <p:sldId id="264" r:id="rId6"/>
  </p:sldIdLst>
  <p:sldSz cx="9144000" cy="6858000" type="screen4x3"/>
  <p:notesSz cx="6769100" cy="9906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53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51652;&#54217;\Dropbox\microkim\&#45436;&#47928;\&#48372;&#45240;&#45436;&#47928;\2019%20Pediatric%20BCR-ABL1-like%20ALL-&#51060;&#51116;&#50865;\Data\191201%20Ped%20Main%20data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&#51652;&#54217;\Dropbox\microkim\&#45436;&#47928;\2019%20Pediatric%20BCR-ABL1-like%20ALL-&#51060;&#51116;&#50865;\Data\190811%20Ped%20Main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E$231</c:f>
              <c:strCache>
                <c:ptCount val="1"/>
                <c:pt idx="0">
                  <c:v>SOX1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2!$E$234,Sheet2!$E$237,Sheet2!$E$240)</c:f>
                <c:numCache>
                  <c:formatCode>General</c:formatCode>
                  <c:ptCount val="3"/>
                  <c:pt idx="0">
                    <c:v>5.0512254216409464E-4</c:v>
                  </c:pt>
                  <c:pt idx="1">
                    <c:v>4.612724978496738E-3</c:v>
                  </c:pt>
                  <c:pt idx="2">
                    <c:v>1.611447685272741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2!$A$232,Sheet2!$A$235,Sheet2!$A$238)</c:f>
              <c:strCache>
                <c:ptCount val="3"/>
                <c:pt idx="0">
                  <c:v>BCR-ABL1-like</c:v>
                </c:pt>
                <c:pt idx="1">
                  <c:v>ETV6-RUNX1-like</c:v>
                </c:pt>
                <c:pt idx="2">
                  <c:v>B-other</c:v>
                </c:pt>
              </c:strCache>
            </c:strRef>
          </c:cat>
          <c:val>
            <c:numRef>
              <c:f>(Sheet2!$E$233,Sheet2!$E$236,Sheet2!$E$239)</c:f>
              <c:numCache>
                <c:formatCode>####.00000000000</c:formatCode>
                <c:ptCount val="3"/>
                <c:pt idx="0">
                  <c:v>1.4369074400000009E-3</c:v>
                </c:pt>
                <c:pt idx="1">
                  <c:v>1.4079261749999994E-2</c:v>
                </c:pt>
                <c:pt idx="2">
                  <c:v>2.424019946153848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527808"/>
        <c:axId val="151529344"/>
      </c:barChart>
      <c:catAx>
        <c:axId val="1515278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151529344"/>
        <c:crosses val="autoZero"/>
        <c:auto val="1"/>
        <c:lblAlgn val="ctr"/>
        <c:lblOffset val="100"/>
        <c:noMultiLvlLbl val="0"/>
      </c:catAx>
      <c:valAx>
        <c:axId val="151529344"/>
        <c:scaling>
          <c:orientation val="minMax"/>
        </c:scaling>
        <c:delete val="0"/>
        <c:axPos val="l"/>
        <c:numFmt formatCode="#,##0.00_);\(#,##0.00\)" sourceLinked="0"/>
        <c:majorTickMark val="out"/>
        <c:minorTickMark val="none"/>
        <c:tickLblPos val="nextTo"/>
        <c:crossAx val="151527808"/>
        <c:crosses val="autoZero"/>
        <c:crossBetween val="between"/>
        <c:majorUnit val="1.0000000000000007E-2"/>
      </c:valAx>
    </c:plotArea>
    <c:plotVisOnly val="1"/>
    <c:dispBlanksAs val="gap"/>
    <c:showDLblsOverMax val="0"/>
  </c:chart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6019047619047624"/>
          <c:y val="0.19402777777777777"/>
          <c:w val="0.78437301587301589"/>
          <c:h val="0.573375338753387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V$2</c:f>
              <c:strCache>
                <c:ptCount val="1"/>
                <c:pt idx="0">
                  <c:v>SEMA6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(Sheet5!$A$3,Sheet5!$A$6,Sheet5!$A$9,Sheet5!$A$12,Sheet5!$A$15)</c:f>
              <c:strCache>
                <c:ptCount val="5"/>
                <c:pt idx="0">
                  <c:v>ABL</c:v>
                </c:pt>
                <c:pt idx="1">
                  <c:v>CRLF2</c:v>
                </c:pt>
                <c:pt idx="2">
                  <c:v>JAK-STAT</c:v>
                </c:pt>
                <c:pt idx="3">
                  <c:v>RAS</c:v>
                </c:pt>
                <c:pt idx="4">
                  <c:v>B-other</c:v>
                </c:pt>
              </c:strCache>
            </c:strRef>
          </c:cat>
          <c:val>
            <c:numRef>
              <c:f>(Sheet5!$AV$4,Sheet5!$AV$7,Sheet5!$AV$10,Sheet5!$AV$13,Sheet5!$AV$16)</c:f>
              <c:numCache>
                <c:formatCode>####.000000000000</c:formatCode>
                <c:ptCount val="5"/>
                <c:pt idx="0">
                  <c:v>1.814865534166668</c:v>
                </c:pt>
                <c:pt idx="1">
                  <c:v>0.97806784149999992</c:v>
                </c:pt>
                <c:pt idx="2">
                  <c:v>1.3295791281666665</c:v>
                </c:pt>
                <c:pt idx="3">
                  <c:v>0.15172108041176496</c:v>
                </c:pt>
                <c:pt idx="4">
                  <c:v>0.58102945157142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2159360"/>
        <c:axId val="152160896"/>
      </c:barChart>
      <c:catAx>
        <c:axId val="152159360"/>
        <c:scaling>
          <c:orientation val="minMax"/>
        </c:scaling>
        <c:delete val="0"/>
        <c:axPos val="b"/>
        <c:majorTickMark val="out"/>
        <c:minorTickMark val="none"/>
        <c:tickLblPos val="nextTo"/>
        <c:crossAx val="152160896"/>
        <c:crosses val="autoZero"/>
        <c:auto val="1"/>
        <c:lblAlgn val="ctr"/>
        <c:lblOffset val="100"/>
        <c:noMultiLvlLbl val="0"/>
      </c:catAx>
      <c:valAx>
        <c:axId val="152160896"/>
        <c:scaling>
          <c:orientation val="minMax"/>
        </c:scaling>
        <c:delete val="0"/>
        <c:axPos val="l"/>
        <c:numFmt formatCode="#,##0.0_);\(#,##0.0\)" sourceLinked="0"/>
        <c:majorTickMark val="out"/>
        <c:minorTickMark val="none"/>
        <c:tickLblPos val="nextTo"/>
        <c:crossAx val="152159360"/>
        <c:crosses val="autoZero"/>
        <c:crossBetween val="between"/>
        <c:majorUnit val="0.5"/>
      </c:valAx>
    </c:plotArea>
    <c:plotVisOnly val="1"/>
    <c:dispBlanksAs val="gap"/>
    <c:showDLblsOverMax val="0"/>
  </c:chart>
  <c:spPr>
    <a:ln w="38100"/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i="1" dirty="0"/>
              <a:t>IRF8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F$231</c:f>
              <c:strCache>
                <c:ptCount val="1"/>
                <c:pt idx="0">
                  <c:v>IRF8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2!$F$234,Sheet2!$F$237,Sheet2!$F$240)</c:f>
                <c:numCache>
                  <c:formatCode>General</c:formatCode>
                  <c:ptCount val="3"/>
                  <c:pt idx="0">
                    <c:v>0.79377056175646266</c:v>
                  </c:pt>
                  <c:pt idx="1">
                    <c:v>0.32187848548668618</c:v>
                  </c:pt>
                  <c:pt idx="2">
                    <c:v>0.778810986243903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2!$A$232,Sheet2!$A$235,Sheet2!$A$238)</c:f>
              <c:strCache>
                <c:ptCount val="3"/>
                <c:pt idx="0">
                  <c:v>BCR-ABL1-like</c:v>
                </c:pt>
                <c:pt idx="1">
                  <c:v>ETV6-RUNX1-like</c:v>
                </c:pt>
                <c:pt idx="2">
                  <c:v>B-other</c:v>
                </c:pt>
              </c:strCache>
            </c:strRef>
          </c:cat>
          <c:val>
            <c:numRef>
              <c:f>(Sheet2!$F$233,Sheet2!$F$236,Sheet2!$F$239)</c:f>
              <c:numCache>
                <c:formatCode>####.00000000000000</c:formatCode>
                <c:ptCount val="3"/>
                <c:pt idx="0">
                  <c:v>2.6409188336933336</c:v>
                </c:pt>
                <c:pt idx="1">
                  <c:v>0.87599298120833335</c:v>
                </c:pt>
                <c:pt idx="2">
                  <c:v>1.99260224134615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541632"/>
        <c:axId val="151543168"/>
      </c:barChart>
      <c:catAx>
        <c:axId val="1515416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151543168"/>
        <c:crosses val="autoZero"/>
        <c:auto val="1"/>
        <c:lblAlgn val="ctr"/>
        <c:lblOffset val="100"/>
        <c:noMultiLvlLbl val="0"/>
      </c:catAx>
      <c:valAx>
        <c:axId val="151543168"/>
        <c:scaling>
          <c:orientation val="minMax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151541632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231</c:f>
              <c:strCache>
                <c:ptCount val="1"/>
                <c:pt idx="0">
                  <c:v>PDGFRB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2!$G$234,Sheet2!$G$237,Sheet2!$G$240)</c:f>
                <c:numCache>
                  <c:formatCode>General</c:formatCode>
                  <c:ptCount val="3"/>
                  <c:pt idx="0">
                    <c:v>2.132465324971123E-2</c:v>
                  </c:pt>
                  <c:pt idx="1">
                    <c:v>3.540340580047313E-3</c:v>
                  </c:pt>
                  <c:pt idx="2">
                    <c:v>8.25946813315030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2!$A$232,Sheet2!$A$235,Sheet2!$A$238)</c:f>
              <c:strCache>
                <c:ptCount val="3"/>
                <c:pt idx="0">
                  <c:v>BCR-ABL1-like</c:v>
                </c:pt>
                <c:pt idx="1">
                  <c:v>ETV6-RUNX1-like</c:v>
                </c:pt>
                <c:pt idx="2">
                  <c:v>B-other</c:v>
                </c:pt>
              </c:strCache>
            </c:strRef>
          </c:cat>
          <c:val>
            <c:numRef>
              <c:f>(Sheet2!$G$233,Sheet2!$G$236,Sheet2!$G$239)</c:f>
              <c:numCache>
                <c:formatCode>####.00000000000000</c:formatCode>
                <c:ptCount val="3"/>
                <c:pt idx="0">
                  <c:v>6.7861730902857201E-2</c:v>
                </c:pt>
                <c:pt idx="1">
                  <c:v>7.8334898214285787E-3</c:v>
                </c:pt>
                <c:pt idx="2">
                  <c:v>2.535750794505495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854464"/>
        <c:axId val="151868544"/>
      </c:barChart>
      <c:catAx>
        <c:axId val="1518544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151868544"/>
        <c:crosses val="autoZero"/>
        <c:auto val="1"/>
        <c:lblAlgn val="ctr"/>
        <c:lblOffset val="100"/>
        <c:noMultiLvlLbl val="0"/>
      </c:catAx>
      <c:valAx>
        <c:axId val="151868544"/>
        <c:scaling>
          <c:orientation val="minMax"/>
          <c:max val="0.1"/>
        </c:scaling>
        <c:delete val="0"/>
        <c:axPos val="l"/>
        <c:numFmt formatCode="#,##0.00_);\(#,##0.00\)" sourceLinked="0"/>
        <c:majorTickMark val="out"/>
        <c:minorTickMark val="none"/>
        <c:tickLblPos val="nextTo"/>
        <c:crossAx val="151854464"/>
        <c:crosses val="autoZero"/>
        <c:crossBetween val="between"/>
        <c:majorUnit val="2.0000000000000011E-2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H$231</c:f>
              <c:strCache>
                <c:ptCount val="1"/>
                <c:pt idx="0">
                  <c:v>SH2B3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2!$H$234,Sheet2!$H$237,Sheet2!$H$240)</c:f>
                <c:numCache>
                  <c:formatCode>General</c:formatCode>
                  <c:ptCount val="3"/>
                  <c:pt idx="0">
                    <c:v>2.592420841298855E-2</c:v>
                  </c:pt>
                  <c:pt idx="1">
                    <c:v>9.249366831936277E-3</c:v>
                  </c:pt>
                  <c:pt idx="2">
                    <c:v>5.819004674870568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2!$A$232,Sheet2!$A$235,Sheet2!$A$238)</c:f>
              <c:strCache>
                <c:ptCount val="3"/>
                <c:pt idx="0">
                  <c:v>BCR-ABL1-like</c:v>
                </c:pt>
                <c:pt idx="1">
                  <c:v>ETV6-RUNX1-like</c:v>
                </c:pt>
                <c:pt idx="2">
                  <c:v>B-other</c:v>
                </c:pt>
              </c:strCache>
            </c:strRef>
          </c:cat>
          <c:val>
            <c:numRef>
              <c:f>(Sheet2!$H$233,Sheet2!$H$236,Sheet2!$H$239)</c:f>
              <c:numCache>
                <c:formatCode>####.00000000000</c:formatCode>
                <c:ptCount val="3"/>
                <c:pt idx="0">
                  <c:v>0.24945431948000019</c:v>
                </c:pt>
                <c:pt idx="1">
                  <c:v>0.12029937900000005</c:v>
                </c:pt>
                <c:pt idx="2">
                  <c:v>0.296065619846153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897216"/>
        <c:axId val="151898752"/>
      </c:barChart>
      <c:catAx>
        <c:axId val="1518972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151898752"/>
        <c:crosses val="autoZero"/>
        <c:auto val="1"/>
        <c:lblAlgn val="ctr"/>
        <c:lblOffset val="100"/>
        <c:noMultiLvlLbl val="0"/>
      </c:catAx>
      <c:valAx>
        <c:axId val="151898752"/>
        <c:scaling>
          <c:orientation val="minMax"/>
        </c:scaling>
        <c:delete val="0"/>
        <c:axPos val="l"/>
        <c:numFmt formatCode="#,##0.0_);\(#,##0.0\)" sourceLinked="0"/>
        <c:majorTickMark val="out"/>
        <c:minorTickMark val="none"/>
        <c:tickLblPos val="nextTo"/>
        <c:crossAx val="151897216"/>
        <c:crosses val="autoZero"/>
        <c:crossBetween val="between"/>
        <c:majorUnit val="0.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I$231</c:f>
              <c:strCache>
                <c:ptCount val="1"/>
                <c:pt idx="0">
                  <c:v>NTRK3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2!$I$234,Sheet2!$I$237,Sheet2!$I$240)</c:f>
                <c:numCache>
                  <c:formatCode>General</c:formatCode>
                  <c:ptCount val="3"/>
                  <c:pt idx="0">
                    <c:v>1.8271802269628033E-4</c:v>
                  </c:pt>
                  <c:pt idx="1">
                    <c:v>7.7184312500000051E-5</c:v>
                  </c:pt>
                  <c:pt idx="2">
                    <c:v>8.37424896618694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2!$A$232,Sheet2!$A$235,Sheet2!$A$238)</c:f>
              <c:strCache>
                <c:ptCount val="3"/>
                <c:pt idx="0">
                  <c:v>BCR-ABL1-like</c:v>
                </c:pt>
                <c:pt idx="1">
                  <c:v>ETV6-RUNX1-like</c:v>
                </c:pt>
                <c:pt idx="2">
                  <c:v>B-other</c:v>
                </c:pt>
              </c:strCache>
            </c:strRef>
          </c:cat>
          <c:val>
            <c:numRef>
              <c:f>(Sheet2!$I$233,Sheet2!$I$236,Sheet2!$I$239)</c:f>
              <c:numCache>
                <c:formatCode>####.00</c:formatCode>
                <c:ptCount val="3"/>
                <c:pt idx="0">
                  <c:v>5.4123352499999987E-4</c:v>
                </c:pt>
                <c:pt idx="1">
                  <c:v>7.7184312500000051E-5</c:v>
                </c:pt>
                <c:pt idx="2">
                  <c:v>8.9842064038461577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911040"/>
        <c:axId val="152183168"/>
      </c:barChart>
      <c:catAx>
        <c:axId val="1519110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152183168"/>
        <c:crosses val="autoZero"/>
        <c:auto val="1"/>
        <c:lblAlgn val="ctr"/>
        <c:lblOffset val="100"/>
        <c:noMultiLvlLbl val="0"/>
      </c:catAx>
      <c:valAx>
        <c:axId val="152183168"/>
        <c:scaling>
          <c:orientation val="minMax"/>
          <c:max val="2.0000000000000011E-2"/>
        </c:scaling>
        <c:delete val="0"/>
        <c:axPos val="l"/>
        <c:numFmt formatCode="#,##0.000_);\(#,##0.000\)" sourceLinked="0"/>
        <c:majorTickMark val="out"/>
        <c:minorTickMark val="none"/>
        <c:tickLblPos val="nextTo"/>
        <c:crossAx val="151911040"/>
        <c:crosses val="autoZero"/>
        <c:crossBetween val="between"/>
        <c:majorUnit val="5.0000000000000044E-3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J$231</c:f>
              <c:strCache>
                <c:ptCount val="1"/>
                <c:pt idx="0">
                  <c:v>CRLF2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Sheet2!$J$234,Sheet2!$J$237,Sheet2!$J$240)</c:f>
                <c:numCache>
                  <c:formatCode>General</c:formatCode>
                  <c:ptCount val="3"/>
                  <c:pt idx="0">
                    <c:v>1.3408950004368081</c:v>
                  </c:pt>
                  <c:pt idx="1">
                    <c:v>1.6975274732391528E-2</c:v>
                  </c:pt>
                  <c:pt idx="2">
                    <c:v>2.216703520823093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2!$A$232,Sheet2!$A$235,Sheet2!$A$238)</c:f>
              <c:strCache>
                <c:ptCount val="3"/>
                <c:pt idx="0">
                  <c:v>BCR-ABL1-like</c:v>
                </c:pt>
                <c:pt idx="1">
                  <c:v>ETV6-RUNX1-like</c:v>
                </c:pt>
                <c:pt idx="2">
                  <c:v>B-other</c:v>
                </c:pt>
              </c:strCache>
            </c:strRef>
          </c:cat>
          <c:val>
            <c:numRef>
              <c:f>(Sheet2!$J$233,Sheet2!$J$236,Sheet2!$J$239)</c:f>
              <c:numCache>
                <c:formatCode>####.0000000000000</c:formatCode>
                <c:ptCount val="3"/>
                <c:pt idx="0">
                  <c:v>1.3884559884600005</c:v>
                </c:pt>
                <c:pt idx="1">
                  <c:v>2.5274812562500037E-2</c:v>
                </c:pt>
                <c:pt idx="2">
                  <c:v>5.549547607692310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2220032"/>
        <c:axId val="152221568"/>
      </c:barChart>
      <c:catAx>
        <c:axId val="1522200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152221568"/>
        <c:crosses val="autoZero"/>
        <c:auto val="1"/>
        <c:lblAlgn val="ctr"/>
        <c:lblOffset val="100"/>
        <c:noMultiLvlLbl val="0"/>
      </c:catAx>
      <c:valAx>
        <c:axId val="152221568"/>
        <c:scaling>
          <c:orientation val="minMax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152220032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4618015873015872"/>
          <c:y val="0.19402777777777777"/>
          <c:w val="0.79838333333333333"/>
          <c:h val="0.573375338753387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Z$2</c:f>
              <c:strCache>
                <c:ptCount val="1"/>
                <c:pt idx="0">
                  <c:v>CRLF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(Sheet5!$A$3,Sheet5!$A$6,Sheet5!$A$9,Sheet5!$A$12,Sheet5!$A$15)</c:f>
              <c:strCache>
                <c:ptCount val="5"/>
                <c:pt idx="0">
                  <c:v>ABL</c:v>
                </c:pt>
                <c:pt idx="1">
                  <c:v>CRLF2</c:v>
                </c:pt>
                <c:pt idx="2">
                  <c:v>JAK-STAT</c:v>
                </c:pt>
                <c:pt idx="3">
                  <c:v>RAS</c:v>
                </c:pt>
                <c:pt idx="4">
                  <c:v>B-other</c:v>
                </c:pt>
              </c:strCache>
            </c:strRef>
          </c:cat>
          <c:val>
            <c:numRef>
              <c:f>(Sheet5!$Z$4,Sheet5!$Z$7,Sheet5!$Z$10,Sheet5!$Z$13,Sheet5!$Z$16)</c:f>
              <c:numCache>
                <c:formatCode>####.0000000000000</c:formatCode>
                <c:ptCount val="5"/>
                <c:pt idx="0">
                  <c:v>8.8306441958333481E-2</c:v>
                </c:pt>
                <c:pt idx="1">
                  <c:v>16.833499326812518</c:v>
                </c:pt>
                <c:pt idx="2">
                  <c:v>9.5551561666666895E-3</c:v>
                </c:pt>
                <c:pt idx="3">
                  <c:v>4.41656625588236E-2</c:v>
                </c:pt>
                <c:pt idx="4">
                  <c:v>9.276279986309521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2047616"/>
        <c:axId val="152049152"/>
      </c:barChart>
      <c:catAx>
        <c:axId val="152047616"/>
        <c:scaling>
          <c:orientation val="minMax"/>
        </c:scaling>
        <c:delete val="0"/>
        <c:axPos val="b"/>
        <c:majorTickMark val="out"/>
        <c:minorTickMark val="none"/>
        <c:tickLblPos val="nextTo"/>
        <c:crossAx val="152049152"/>
        <c:crosses val="autoZero"/>
        <c:auto val="1"/>
        <c:lblAlgn val="ctr"/>
        <c:lblOffset val="100"/>
        <c:noMultiLvlLbl val="0"/>
      </c:catAx>
      <c:valAx>
        <c:axId val="152049152"/>
        <c:scaling>
          <c:orientation val="minMax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152047616"/>
        <c:crosses val="autoZero"/>
        <c:crossBetween val="between"/>
        <c:majorUnit val="4"/>
      </c:valAx>
    </c:plotArea>
    <c:plotVisOnly val="1"/>
    <c:dispBlanksAs val="gap"/>
    <c:showDLblsOverMax val="0"/>
  </c:chart>
  <c:spPr>
    <a:ln w="38100"/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txPr>
        <a:bodyPr/>
        <a:lstStyle/>
        <a:p>
          <a:pPr>
            <a:defRPr sz="1400" i="1"/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4618015873015872"/>
          <c:y val="0.17251693766937687"/>
          <c:w val="0.79838333333333333"/>
          <c:h val="0.594886178861787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N$2</c:f>
              <c:strCache>
                <c:ptCount val="1"/>
                <c:pt idx="0">
                  <c:v>EBF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(Sheet5!$A$3,Sheet5!$A$6,Sheet5!$A$9,Sheet5!$A$12,Sheet5!$A$15)</c:f>
              <c:strCache>
                <c:ptCount val="5"/>
                <c:pt idx="0">
                  <c:v>ABL</c:v>
                </c:pt>
                <c:pt idx="1">
                  <c:v>CRLF2</c:v>
                </c:pt>
                <c:pt idx="2">
                  <c:v>JAK-STAT</c:v>
                </c:pt>
                <c:pt idx="3">
                  <c:v>RAS</c:v>
                </c:pt>
                <c:pt idx="4">
                  <c:v>B-other</c:v>
                </c:pt>
              </c:strCache>
            </c:strRef>
          </c:cat>
          <c:val>
            <c:numRef>
              <c:f>(Sheet5!$AN$4,Sheet5!$AN$7,Sheet5!$AN$10,Sheet5!$AN$13,Sheet5!$AN$16)</c:f>
              <c:numCache>
                <c:formatCode>####.00000000000000</c:formatCode>
                <c:ptCount val="5"/>
                <c:pt idx="0">
                  <c:v>10.018179125222218</c:v>
                </c:pt>
                <c:pt idx="1">
                  <c:v>7.1193082636666674</c:v>
                </c:pt>
                <c:pt idx="2">
                  <c:v>9.6528982641666747</c:v>
                </c:pt>
                <c:pt idx="3">
                  <c:v>4.4242178250196078</c:v>
                </c:pt>
                <c:pt idx="4">
                  <c:v>6.34926009848414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2073344"/>
        <c:axId val="152074880"/>
      </c:barChart>
      <c:catAx>
        <c:axId val="152073344"/>
        <c:scaling>
          <c:orientation val="minMax"/>
        </c:scaling>
        <c:delete val="0"/>
        <c:axPos val="b"/>
        <c:majorTickMark val="out"/>
        <c:minorTickMark val="none"/>
        <c:tickLblPos val="nextTo"/>
        <c:crossAx val="152074880"/>
        <c:crosses val="autoZero"/>
        <c:auto val="1"/>
        <c:lblAlgn val="ctr"/>
        <c:lblOffset val="100"/>
        <c:noMultiLvlLbl val="0"/>
      </c:catAx>
      <c:valAx>
        <c:axId val="152074880"/>
        <c:scaling>
          <c:orientation val="minMax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152073344"/>
        <c:crosses val="autoZero"/>
        <c:crossBetween val="between"/>
      </c:valAx>
    </c:plotArea>
    <c:plotVisOnly val="1"/>
    <c:dispBlanksAs val="gap"/>
    <c:showDLblsOverMax val="0"/>
  </c:chart>
  <c:spPr>
    <a:ln w="38100"/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axId val="152086016"/>
        <c:axId val="152087552"/>
      </c:barChart>
      <c:catAx>
        <c:axId val="152086016"/>
        <c:scaling>
          <c:orientation val="minMax"/>
        </c:scaling>
        <c:delete val="0"/>
        <c:axPos val="b"/>
        <c:majorTickMark val="out"/>
        <c:minorTickMark val="none"/>
        <c:tickLblPos val="nextTo"/>
        <c:crossAx val="152087552"/>
        <c:crosses val="autoZero"/>
        <c:auto val="1"/>
        <c:lblAlgn val="ctr"/>
        <c:lblOffset val="100"/>
        <c:noMultiLvlLbl val="0"/>
      </c:catAx>
      <c:valAx>
        <c:axId val="152087552"/>
        <c:scaling>
          <c:orientation val="minMax"/>
        </c:scaling>
        <c:delete val="0"/>
        <c:axPos val="l"/>
        <c:numFmt formatCode="0.00E+00" sourceLinked="0"/>
        <c:majorTickMark val="out"/>
        <c:minorTickMark val="none"/>
        <c:tickLblPos val="nextTo"/>
        <c:crossAx val="152086016"/>
        <c:crosses val="autoZero"/>
        <c:crossBetween val="between"/>
        <c:majorUnit val="0.5"/>
      </c:valAx>
    </c:plotArea>
    <c:plotVisOnly val="1"/>
    <c:dispBlanksAs val="gap"/>
    <c:showDLblsOverMax val="0"/>
  </c:chart>
  <c:spPr>
    <a:ln w="38100"/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2504</cdr:x>
      <cdr:y>0.19226</cdr:y>
    </cdr:from>
    <cdr:to>
      <cdr:x>0.73532</cdr:x>
      <cdr:y>0.19226</cdr:y>
    </cdr:to>
    <cdr:cxnSp macro="">
      <cdr:nvCxnSpPr>
        <cdr:cNvPr id="2" name="직선 연결선 1"/>
        <cdr:cNvCxnSpPr/>
      </cdr:nvCxnSpPr>
      <cdr:spPr>
        <a:xfrm xmlns:a="http://schemas.openxmlformats.org/drawingml/2006/main">
          <a:off x="901602" y="567674"/>
          <a:ext cx="1138039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976</cdr:x>
      <cdr:y>0.11623</cdr:y>
    </cdr:from>
    <cdr:to>
      <cdr:x>0.60001</cdr:x>
      <cdr:y>0.19962</cdr:y>
    </cdr:to>
    <cdr:sp macro="" textlink="">
      <cdr:nvSpPr>
        <cdr:cNvPr id="3" name="TextBox 6"/>
        <cdr:cNvSpPr txBox="1"/>
      </cdr:nvSpPr>
      <cdr:spPr>
        <a:xfrm xmlns:a="http://schemas.openxmlformats.org/drawingml/2006/main">
          <a:off x="1380257" y="343183"/>
          <a:ext cx="284052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ko-KR"/>
          </a:defPPr>
          <a:lvl1pPr marL="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1pPr>
          <a:lvl2pPr marL="4572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2pPr>
          <a:lvl3pPr marL="9144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3pPr>
          <a:lvl4pPr marL="13716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4pPr>
          <a:lvl5pPr marL="18288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5pPr>
          <a:lvl6pPr marL="22860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6pPr>
          <a:lvl7pPr marL="27432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7pPr>
          <a:lvl8pPr marL="32004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8pPr>
          <a:lvl9pPr marL="36576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9pPr>
        </a:lstStyle>
        <a:p xmlns:a="http://schemas.openxmlformats.org/drawingml/2006/main">
          <a:r>
            <a:rPr lang="en-US" altLang="ko-KR" sz="1000" dirty="0" smtClean="0">
              <a:latin typeface="Arial" pitchFamily="34" charset="0"/>
              <a:cs typeface="Arial" pitchFamily="34" charset="0"/>
            </a:rPr>
            <a:t>**</a:t>
          </a:r>
          <a:endParaRPr lang="ko-KR" altLang="en-US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54952</cdr:x>
      <cdr:y>0.23817</cdr:y>
    </cdr:from>
    <cdr:to>
      <cdr:x>0.63401</cdr:x>
      <cdr:y>0.32156</cdr:y>
    </cdr:to>
    <cdr:sp macro="" textlink="">
      <cdr:nvSpPr>
        <cdr:cNvPr id="5" name="TextBox 6"/>
        <cdr:cNvSpPr txBox="1"/>
      </cdr:nvSpPr>
      <cdr:spPr>
        <a:xfrm xmlns:a="http://schemas.openxmlformats.org/drawingml/2006/main">
          <a:off x="1524273" y="703223"/>
          <a:ext cx="23436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ko-KR"/>
          </a:defPPr>
          <a:lvl1pPr marL="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1pPr>
          <a:lvl2pPr marL="4572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2pPr>
          <a:lvl3pPr marL="9144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3pPr>
          <a:lvl4pPr marL="13716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4pPr>
          <a:lvl5pPr marL="18288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5pPr>
          <a:lvl6pPr marL="22860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6pPr>
          <a:lvl7pPr marL="27432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7pPr>
          <a:lvl8pPr marL="32004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8pPr>
          <a:lvl9pPr marL="36576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9pPr>
        </a:lstStyle>
        <a:p xmlns:a="http://schemas.openxmlformats.org/drawingml/2006/main">
          <a:r>
            <a:rPr lang="en-US" altLang="ko-KR" sz="1000" dirty="0" smtClean="0">
              <a:latin typeface="Arial" pitchFamily="34" charset="0"/>
              <a:cs typeface="Arial" pitchFamily="34" charset="0"/>
            </a:rPr>
            <a:t>*</a:t>
          </a:r>
          <a:endParaRPr lang="ko-KR" altLang="en-US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60755</cdr:x>
      <cdr:y>0.33572</cdr:y>
    </cdr:from>
    <cdr:to>
      <cdr:x>0.74431</cdr:x>
      <cdr:y>0.33572</cdr:y>
    </cdr:to>
    <cdr:cxnSp macro="">
      <cdr:nvCxnSpPr>
        <cdr:cNvPr id="7" name="직선 연결선 6"/>
        <cdr:cNvCxnSpPr/>
      </cdr:nvCxnSpPr>
      <cdr:spPr>
        <a:xfrm xmlns:a="http://schemas.openxmlformats.org/drawingml/2006/main">
          <a:off x="1685223" y="991255"/>
          <a:ext cx="379346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274</cdr:x>
      <cdr:y>0.28695</cdr:y>
    </cdr:from>
    <cdr:to>
      <cdr:x>0.73125</cdr:x>
      <cdr:y>0.37034</cdr:y>
    </cdr:to>
    <cdr:sp macro="" textlink="">
      <cdr:nvSpPr>
        <cdr:cNvPr id="8" name="TextBox 6"/>
        <cdr:cNvSpPr txBox="1"/>
      </cdr:nvSpPr>
      <cdr:spPr>
        <a:xfrm xmlns:a="http://schemas.openxmlformats.org/drawingml/2006/main">
          <a:off x="1740297" y="847239"/>
          <a:ext cx="288041" cy="24621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ko-KR"/>
          </a:defPPr>
          <a:lvl1pPr marL="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1pPr>
          <a:lvl2pPr marL="4572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2pPr>
          <a:lvl3pPr marL="9144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3pPr>
          <a:lvl4pPr marL="13716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4pPr>
          <a:lvl5pPr marL="18288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5pPr>
          <a:lvl6pPr marL="22860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6pPr>
          <a:lvl7pPr marL="27432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7pPr>
          <a:lvl8pPr marL="32004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8pPr>
          <a:lvl9pPr marL="3657600" algn="l" defTabSz="914400" rtl="0" eaLnBrk="1" latinLnBrk="1" hangingPunct="1">
            <a:defRPr sz="1800" kern="1200">
              <a:solidFill>
                <a:sysClr val="windowText" lastClr="000000"/>
              </a:solidFill>
              <a:latin typeface="맑은 고딕"/>
            </a:defRPr>
          </a:lvl9pPr>
        </a:lstStyle>
        <a:p xmlns:a="http://schemas.openxmlformats.org/drawingml/2006/main">
          <a:r>
            <a:rPr lang="en-US" altLang="ko-KR" sz="1000" dirty="0" smtClean="0">
              <a:latin typeface="Arial" pitchFamily="34" charset="0"/>
              <a:cs typeface="Arial" pitchFamily="34" charset="0"/>
            </a:rPr>
            <a:t>*</a:t>
          </a:r>
          <a:endParaRPr lang="ko-KR" altLang="en-US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32504</cdr:x>
      <cdr:y>0.19226</cdr:y>
    </cdr:from>
    <cdr:to>
      <cdr:x>0.73532</cdr:x>
      <cdr:y>0.19226</cdr:y>
    </cdr:to>
    <cdr:cxnSp macro="">
      <cdr:nvCxnSpPr>
        <cdr:cNvPr id="11" name="직선 연결선 10"/>
        <cdr:cNvCxnSpPr/>
      </cdr:nvCxnSpPr>
      <cdr:spPr>
        <a:xfrm xmlns:a="http://schemas.openxmlformats.org/drawingml/2006/main">
          <a:off x="901602" y="567674"/>
          <a:ext cx="1138039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2504</cdr:x>
      <cdr:y>0.19226</cdr:y>
    </cdr:from>
    <cdr:to>
      <cdr:x>0.74554</cdr:x>
      <cdr:y>0.19226</cdr:y>
    </cdr:to>
    <cdr:cxnSp macro="">
      <cdr:nvCxnSpPr>
        <cdr:cNvPr id="12" name="직선 연결선 11"/>
        <cdr:cNvCxnSpPr/>
      </cdr:nvCxnSpPr>
      <cdr:spPr>
        <a:xfrm xmlns:a="http://schemas.openxmlformats.org/drawingml/2006/main">
          <a:off x="901599" y="567665"/>
          <a:ext cx="11664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9B440-EFD1-4FAF-9F95-3F2A9BE9DB6A}" type="datetimeFigureOut">
              <a:rPr lang="ko-KR" altLang="en-US" smtClean="0"/>
              <a:pPr/>
              <a:t>2020-04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48A99-8A42-4C1E-A207-50D5185D0B7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3963813"/>
              </p:ext>
            </p:extLst>
          </p:nvPr>
        </p:nvGraphicFramePr>
        <p:xfrm>
          <a:off x="179508" y="1052736"/>
          <a:ext cx="8784979" cy="518306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6034"/>
                <a:gridCol w="706034"/>
                <a:gridCol w="2029847"/>
                <a:gridCol w="1662124"/>
                <a:gridCol w="1709928"/>
                <a:gridCol w="706034"/>
                <a:gridCol w="1264978"/>
              </a:tblGrid>
              <a:tr h="29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tient No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.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Genomic Loca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Nucleotide chan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mino acid chan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AF(%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yp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K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2:253982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M_004985.3:c.38G&gt;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P_004976.2:p.Gly13As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8.6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</a:p>
                  </a:txBody>
                  <a:tcPr marL="103157" marR="8596" marT="859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5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4.1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8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3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3.62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K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2:253982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M_004985.3:c.35G&gt;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4976.2:p.Gly12V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6.2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K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2:253982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M_004985.3:c.38G&gt;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4976.2:p.Gly13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.6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9766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F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7:29546136,chr17:296528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2.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Exon(s) Skipp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5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As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8.2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4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S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6.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PTPN1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2:1129268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834.3:c.1472C&gt;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P_002825.3:p.Pro491Leu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1.8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PTPN1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2:11292687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834.3:c.1492C&gt;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P_002825.3:p.Arg498Tr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4.3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4G&gt;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Cy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7.8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5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97661"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F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7:29548947,chr17:295521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7.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Exon(s) Skipp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8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3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2.9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K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2:253982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4985.3:c.35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4976.2:p.Gly12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1.6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8G&gt;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3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.1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PTPN1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2:1129268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834.3:c.1504T&gt;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825.3:p.Ser502Al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8.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4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S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9.8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5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As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6.5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4G&gt;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S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4.52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noFill/>
                  </a:tcPr>
                </a:tc>
              </a:tr>
              <a:tr h="214504"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i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RA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chr1:1152587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M_002524.4:c.35G&gt;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P_002515.1:p.Gly12V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6.3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SNV-missen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50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VAF, variant</a:t>
                      </a:r>
                      <a:r>
                        <a:rPr lang="en-US" altLang="ko-KR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allele frequency; SNV, single nucleotide variation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596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3157" marR="8596" marT="859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내용 개체 틀 2">
            <a:extLst>
              <a:ext uri="{FF2B5EF4-FFF2-40B4-BE49-F238E27FC236}">
                <a16:creationId xmlns="" xmlns:a16="http://schemas.microsoft.com/office/drawing/2014/main" id="{DD85E063-458E-494A-A0FE-CE19F815E964}"/>
              </a:ext>
            </a:extLst>
          </p:cNvPr>
          <p:cNvSpPr txBox="1">
            <a:spLocks/>
          </p:cNvSpPr>
          <p:nvPr/>
        </p:nvSpPr>
        <p:spPr>
          <a:xfrm>
            <a:off x="179512" y="620688"/>
            <a:ext cx="8784976" cy="864096"/>
          </a:xfrm>
          <a:prstGeom prst="rect">
            <a:avLst/>
          </a:prstGeom>
        </p:spPr>
        <p:txBody>
          <a:bodyPr vert="horz" lIns="91408" tIns="45704" rIns="91408" bIns="45704" rtlCol="0">
            <a:noAutofit/>
          </a:bodyPr>
          <a:lstStyle>
            <a:lvl1pPr marL="342778" indent="-342778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688" indent="-285650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2597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599635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6674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3713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750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790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4829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Supplementary Table S1. RAS mutations in 17 subjects</a:t>
            </a:r>
          </a:p>
        </p:txBody>
      </p:sp>
    </p:spTree>
    <p:extLst>
      <p:ext uri="{BB962C8B-B14F-4D97-AF65-F5344CB8AC3E}">
        <p14:creationId xmlns:p14="http://schemas.microsoft.com/office/powerpoint/2010/main" val="2697121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="" xmlns:a16="http://schemas.microsoft.com/office/drawing/2014/main" id="{459428C9-4BA9-4D3A-AC82-893F1DEAAEA7}"/>
              </a:ext>
            </a:extLst>
          </p:cNvPr>
          <p:cNvSpPr/>
          <p:nvPr/>
        </p:nvSpPr>
        <p:spPr>
          <a:xfrm>
            <a:off x="6367288" y="2378773"/>
            <a:ext cx="2142384" cy="2627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optimal RNA (</a:t>
            </a:r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4)</a:t>
            </a:r>
            <a:endParaRPr lang="en-US" altLang="ko-KR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="" xmlns:a16="http://schemas.microsoft.com/office/drawing/2014/main" id="{A6986A81-48EE-4D0E-A28F-0260B3709D9A}"/>
              </a:ext>
            </a:extLst>
          </p:cNvPr>
          <p:cNvSpPr/>
          <p:nvPr/>
        </p:nvSpPr>
        <p:spPr>
          <a:xfrm>
            <a:off x="3244375" y="630313"/>
            <a:ext cx="2335737" cy="658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diatric B-ALL</a:t>
            </a:r>
            <a:endParaRPr lang="en-US" altLang="ko-KR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90)</a:t>
            </a:r>
            <a:endParaRPr lang="ko-KR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>
            <a:extLst>
              <a:ext uri="{FF2B5EF4-FFF2-40B4-BE49-F238E27FC236}">
                <a16:creationId xmlns="" xmlns:a16="http://schemas.microsoft.com/office/drawing/2014/main" id="{FF4410B8-FD85-4DFD-A0DE-1916C98739A3}"/>
              </a:ext>
            </a:extLst>
          </p:cNvPr>
          <p:cNvSpPr/>
          <p:nvPr/>
        </p:nvSpPr>
        <p:spPr>
          <a:xfrm>
            <a:off x="1403984" y="1739311"/>
            <a:ext cx="3024000" cy="6013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urrent genetic abnormalities</a:t>
            </a:r>
          </a:p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27</a:t>
            </a:r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6.8</a:t>
            </a:r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)</a:t>
            </a:r>
          </a:p>
        </p:txBody>
      </p:sp>
      <p:sp>
        <p:nvSpPr>
          <p:cNvPr id="14" name="직사각형 13">
            <a:extLst>
              <a:ext uri="{FF2B5EF4-FFF2-40B4-BE49-F238E27FC236}">
                <a16:creationId xmlns="" xmlns:a16="http://schemas.microsoft.com/office/drawing/2014/main" id="{D374EEC3-2A1C-4F21-A8C1-B11A14E292D2}"/>
              </a:ext>
            </a:extLst>
          </p:cNvPr>
          <p:cNvSpPr/>
          <p:nvPr/>
        </p:nvSpPr>
        <p:spPr>
          <a:xfrm>
            <a:off x="4555919" y="1739310"/>
            <a:ext cx="3024000" cy="6013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recurrent genetic abnormalities</a:t>
            </a:r>
          </a:p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63; 33.2</a:t>
            </a:r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)</a:t>
            </a:r>
          </a:p>
        </p:txBody>
      </p:sp>
      <p:sp>
        <p:nvSpPr>
          <p:cNvPr id="16" name="직사각형 15">
            <a:extLst>
              <a:ext uri="{FF2B5EF4-FFF2-40B4-BE49-F238E27FC236}">
                <a16:creationId xmlns="" xmlns:a16="http://schemas.microsoft.com/office/drawing/2014/main" id="{BFF08538-83E2-44DF-B084-F077E6D71EB0}"/>
              </a:ext>
            </a:extLst>
          </p:cNvPr>
          <p:cNvSpPr/>
          <p:nvPr/>
        </p:nvSpPr>
        <p:spPr>
          <a:xfrm>
            <a:off x="6156177" y="3664334"/>
            <a:ext cx="1440159" cy="52322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ne identified</a:t>
            </a:r>
            <a:endParaRPr lang="en-US" altLang="ko-KR" sz="1400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n=16; 8.4%)</a:t>
            </a:r>
            <a:endParaRPr lang="en-US" altLang="ko-K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꺾인 연결선 43">
            <a:extLst>
              <a:ext uri="{FF2B5EF4-FFF2-40B4-BE49-F238E27FC236}">
                <a16:creationId xmlns="" xmlns:a16="http://schemas.microsoft.com/office/drawing/2014/main" id="{8AA1F24C-2AB7-41CD-85D2-455B6EEA8F4E}"/>
              </a:ext>
            </a:extLst>
          </p:cNvPr>
          <p:cNvCxnSpPr>
            <a:endCxn id="13" idx="0"/>
          </p:cNvCxnSpPr>
          <p:nvPr/>
        </p:nvCxnSpPr>
        <p:spPr>
          <a:xfrm rot="10800000" flipV="1">
            <a:off x="2915984" y="1523283"/>
            <a:ext cx="1512000" cy="216027"/>
          </a:xfrm>
          <a:prstGeom prst="bentConnector2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꺾인 연결선 45">
            <a:extLst>
              <a:ext uri="{FF2B5EF4-FFF2-40B4-BE49-F238E27FC236}">
                <a16:creationId xmlns="" xmlns:a16="http://schemas.microsoft.com/office/drawing/2014/main" id="{A95BAB1D-0092-4EAB-A565-9E7EF10D6F9F}"/>
              </a:ext>
            </a:extLst>
          </p:cNvPr>
          <p:cNvCxnSpPr/>
          <p:nvPr/>
        </p:nvCxnSpPr>
        <p:spPr>
          <a:xfrm rot="16200000" flipH="1">
            <a:off x="5029200" y="687051"/>
            <a:ext cx="421763" cy="1655675"/>
          </a:xfrm>
          <a:prstGeom prst="bentConnector3">
            <a:avLst>
              <a:gd name="adj1" fmla="val 50000"/>
            </a:avLst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직사각형 21">
            <a:extLst>
              <a:ext uri="{FF2B5EF4-FFF2-40B4-BE49-F238E27FC236}">
                <a16:creationId xmlns="" xmlns:a16="http://schemas.microsoft.com/office/drawing/2014/main" id="{DA3450DA-7A21-42A8-86AD-F0FF3119835E}"/>
              </a:ext>
            </a:extLst>
          </p:cNvPr>
          <p:cNvSpPr/>
          <p:nvPr/>
        </p:nvSpPr>
        <p:spPr>
          <a:xfrm>
            <a:off x="4555919" y="3664360"/>
            <a:ext cx="1368152" cy="52322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endParaRPr lang="en-US" altLang="ko-KR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n=33;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7.4%)</a:t>
            </a:r>
            <a:endParaRPr lang="en-US" altLang="ko-K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직사각형 27">
            <a:extLst>
              <a:ext uri="{FF2B5EF4-FFF2-40B4-BE49-F238E27FC236}">
                <a16:creationId xmlns="" xmlns:a16="http://schemas.microsoft.com/office/drawing/2014/main" id="{2CBE3E68-74F5-46B0-A986-03C67694079B}"/>
              </a:ext>
            </a:extLst>
          </p:cNvPr>
          <p:cNvSpPr/>
          <p:nvPr/>
        </p:nvSpPr>
        <p:spPr>
          <a:xfrm>
            <a:off x="4555919" y="2675412"/>
            <a:ext cx="3024000" cy="5303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rther genetic analyses</a:t>
            </a:r>
            <a:endParaRPr lang="en-US" altLang="ko-KR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49; 25.8%)</a:t>
            </a:r>
            <a:endParaRPr lang="en-US" altLang="ko-KR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화살표 연결선 28">
            <a:extLst>
              <a:ext uri="{FF2B5EF4-FFF2-40B4-BE49-F238E27FC236}">
                <a16:creationId xmlns="" xmlns:a16="http://schemas.microsoft.com/office/drawing/2014/main" id="{841DA3A7-64F0-461D-A2F9-371DB14C5E8F}"/>
              </a:ext>
            </a:extLst>
          </p:cNvPr>
          <p:cNvCxnSpPr>
            <a:stCxn id="14" idx="2"/>
            <a:endCxn id="28" idx="0"/>
          </p:cNvCxnSpPr>
          <p:nvPr/>
        </p:nvCxnSpPr>
        <p:spPr>
          <a:xfrm>
            <a:off x="6067919" y="2340635"/>
            <a:ext cx="0" cy="334777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꺾인 연결선 29">
            <a:extLst>
              <a:ext uri="{FF2B5EF4-FFF2-40B4-BE49-F238E27FC236}">
                <a16:creationId xmlns="" xmlns:a16="http://schemas.microsoft.com/office/drawing/2014/main" id="{1543EFD4-D092-492F-809B-2F46AE95FB1A}"/>
              </a:ext>
            </a:extLst>
          </p:cNvPr>
          <p:cNvCxnSpPr>
            <a:stCxn id="28" idx="2"/>
            <a:endCxn id="16" idx="0"/>
          </p:cNvCxnSpPr>
          <p:nvPr/>
        </p:nvCxnSpPr>
        <p:spPr>
          <a:xfrm rot="16200000" flipH="1">
            <a:off x="6242795" y="3030871"/>
            <a:ext cx="458587" cy="808338"/>
          </a:xfrm>
          <a:prstGeom prst="bentConnector3">
            <a:avLst>
              <a:gd name="adj1" fmla="val 50000"/>
            </a:avLst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꺾인 연결선 30">
            <a:extLst>
              <a:ext uri="{FF2B5EF4-FFF2-40B4-BE49-F238E27FC236}">
                <a16:creationId xmlns="" xmlns:a16="http://schemas.microsoft.com/office/drawing/2014/main" id="{180930EC-4B3C-47B8-AF05-A0FF82ED3FC2}"/>
              </a:ext>
            </a:extLst>
          </p:cNvPr>
          <p:cNvCxnSpPr>
            <a:stCxn id="28" idx="2"/>
            <a:endCxn id="22" idx="0"/>
          </p:cNvCxnSpPr>
          <p:nvPr/>
        </p:nvCxnSpPr>
        <p:spPr>
          <a:xfrm rot="5400000">
            <a:off x="5424651" y="3021091"/>
            <a:ext cx="458613" cy="827924"/>
          </a:xfrm>
          <a:prstGeom prst="bentConnector3">
            <a:avLst>
              <a:gd name="adj1" fmla="val 50000"/>
            </a:avLst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>
            <a:extLst>
              <a:ext uri="{FF2B5EF4-FFF2-40B4-BE49-F238E27FC236}">
                <a16:creationId xmlns="" xmlns:a16="http://schemas.microsoft.com/office/drawing/2014/main" id="{03451DAB-2028-456B-AC4C-A46488EA36F0}"/>
              </a:ext>
            </a:extLst>
          </p:cNvPr>
          <p:cNvCxnSpPr>
            <a:endCxn id="7" idx="1"/>
          </p:cNvCxnSpPr>
          <p:nvPr/>
        </p:nvCxnSpPr>
        <p:spPr>
          <a:xfrm>
            <a:off x="6084168" y="2510158"/>
            <a:ext cx="283120" cy="1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내용 개체 틀 2">
            <a:extLst>
              <a:ext uri="{FF2B5EF4-FFF2-40B4-BE49-F238E27FC236}">
                <a16:creationId xmlns="" xmlns:a16="http://schemas.microsoft.com/office/drawing/2014/main" id="{DD85E063-458E-494A-A0FE-CE19F815E964}"/>
              </a:ext>
            </a:extLst>
          </p:cNvPr>
          <p:cNvSpPr txBox="1">
            <a:spLocks/>
          </p:cNvSpPr>
          <p:nvPr/>
        </p:nvSpPr>
        <p:spPr>
          <a:xfrm>
            <a:off x="1043608" y="4653136"/>
            <a:ext cx="7344816" cy="1224136"/>
          </a:xfrm>
          <a:prstGeom prst="rect">
            <a:avLst/>
          </a:prstGeom>
        </p:spPr>
        <p:txBody>
          <a:bodyPr vert="horz" lIns="91408" tIns="45704" rIns="91408" bIns="45704" rtlCol="0">
            <a:noAutofit/>
          </a:bodyPr>
          <a:lstStyle>
            <a:lvl1pPr marL="342778" indent="-342778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688" indent="-285650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2597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599635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6674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3713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750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790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4829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Supplementary Figure S1. Flow chart showing the study design and patient selection. ‘Identified’ subgroup comprises patients with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BCR-ABL1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-like ALL (N=25),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ETV6-RUNX1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-like ALL (N=4), iAMP21 (N=2) and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EWSR1-ZNF384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 (N=2). B-ALL, precursor B-cell acute lymphoblastic leukemia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/>
          <p:nvPr/>
        </p:nvGraphicFramePr>
        <p:xfrm>
          <a:off x="6012440" y="2996952"/>
          <a:ext cx="25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차트 2"/>
          <p:cNvGraphicFramePr/>
          <p:nvPr/>
        </p:nvGraphicFramePr>
        <p:xfrm>
          <a:off x="6156175" y="476672"/>
          <a:ext cx="2359949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차트 3"/>
          <p:cNvGraphicFramePr/>
          <p:nvPr/>
        </p:nvGraphicFramePr>
        <p:xfrm>
          <a:off x="3203848" y="476672"/>
          <a:ext cx="25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차트 4"/>
          <p:cNvGraphicFramePr/>
          <p:nvPr/>
        </p:nvGraphicFramePr>
        <p:xfrm>
          <a:off x="375881" y="2996952"/>
          <a:ext cx="25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차트 5"/>
          <p:cNvGraphicFramePr/>
          <p:nvPr/>
        </p:nvGraphicFramePr>
        <p:xfrm>
          <a:off x="3203848" y="2996952"/>
          <a:ext cx="25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차트 6"/>
          <p:cNvGraphicFramePr/>
          <p:nvPr/>
        </p:nvGraphicFramePr>
        <p:xfrm>
          <a:off x="467544" y="476672"/>
          <a:ext cx="25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8" name="직선 연결선 7"/>
          <p:cNvCxnSpPr/>
          <p:nvPr/>
        </p:nvCxnSpPr>
        <p:spPr>
          <a:xfrm>
            <a:off x="1122371" y="989103"/>
            <a:ext cx="13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/>
          <p:cNvCxnSpPr/>
          <p:nvPr/>
        </p:nvCxnSpPr>
        <p:spPr>
          <a:xfrm>
            <a:off x="1115007" y="971103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/>
          <p:cNvCxnSpPr/>
          <p:nvPr/>
        </p:nvCxnSpPr>
        <p:spPr>
          <a:xfrm>
            <a:off x="2500702" y="971103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691680" y="81995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직선 연결선 13"/>
          <p:cNvCxnSpPr/>
          <p:nvPr/>
        </p:nvCxnSpPr>
        <p:spPr>
          <a:xfrm>
            <a:off x="3995936" y="989103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>
            <a:off x="3988572" y="971103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5266679" y="971103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534414" y="81995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6777135" y="989103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6769771" y="971103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8036851" y="971103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7289968" y="81995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1130838" y="3528637"/>
            <a:ext cx="12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/>
          <p:cNvCxnSpPr/>
          <p:nvPr/>
        </p:nvCxnSpPr>
        <p:spPr>
          <a:xfrm>
            <a:off x="1123474" y="3510637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2428694" y="3510637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658172" y="335699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직선 연결선 25"/>
          <p:cNvCxnSpPr/>
          <p:nvPr/>
        </p:nvCxnSpPr>
        <p:spPr>
          <a:xfrm>
            <a:off x="3987469" y="3528637"/>
            <a:ext cx="12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>
          <a:xfrm>
            <a:off x="3980105" y="3510637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>
          <a:xfrm>
            <a:off x="5292015" y="3510637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4515164" y="335699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>
            <a:off x="6748555" y="3528637"/>
            <a:ext cx="12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6741191" y="3510637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8046411" y="3510637"/>
            <a:ext cx="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265171" y="335699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**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내용 개체 틀 2">
            <a:extLst>
              <a:ext uri="{FF2B5EF4-FFF2-40B4-BE49-F238E27FC236}">
                <a16:creationId xmlns="" xmlns:a16="http://schemas.microsoft.com/office/drawing/2014/main" id="{DD85E063-458E-494A-A0FE-CE19F815E964}"/>
              </a:ext>
            </a:extLst>
          </p:cNvPr>
          <p:cNvSpPr txBox="1">
            <a:spLocks/>
          </p:cNvSpPr>
          <p:nvPr/>
        </p:nvSpPr>
        <p:spPr>
          <a:xfrm>
            <a:off x="1043608" y="5633864"/>
            <a:ext cx="7344816" cy="603448"/>
          </a:xfrm>
          <a:prstGeom prst="rect">
            <a:avLst/>
          </a:prstGeom>
        </p:spPr>
        <p:txBody>
          <a:bodyPr vert="horz" lIns="91408" tIns="45704" rIns="91408" bIns="45704" rtlCol="0">
            <a:noAutofit/>
          </a:bodyPr>
          <a:lstStyle>
            <a:lvl1pPr marL="342778" indent="-342778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688" indent="-285650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2597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599635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6674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3713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750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790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4829" indent="-228519" algn="l" defTabSz="914077" rtl="0" eaLnBrk="1" latinLnBrk="1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Supplementary Figure S2. Gene expression of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BCR-ABL1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-like,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ETV6-RUNX1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-like and B-other acute lymphoblastic leukemia. *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 &lt;0.05, **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P &lt;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0.01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827584" y="5085184"/>
            <a:ext cx="763284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Supplementary Figure S3. Comparison of gene expression within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BCR-ABL1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-like acute lymphoblastic leukemia subgroup. ABL, ABL-class fusions; CRLF2,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CRLF2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 rearrangements;  JAK-STAT, JAK-STAT pathway mutations; RAS, RAS pathway mutations. *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 &lt;0.05, ** </a:t>
            </a:r>
            <a:r>
              <a:rPr lang="en-US" altLang="ko-KR" sz="1600" i="1" dirty="0" smtClean="0">
                <a:latin typeface="Arial" pitchFamily="34" charset="0"/>
                <a:cs typeface="Arial" pitchFamily="34" charset="0"/>
              </a:rPr>
              <a:t>P &lt;</a:t>
            </a:r>
            <a:r>
              <a:rPr lang="en-US" altLang="ko-KR" sz="1600" dirty="0" smtClean="0">
                <a:latin typeface="Arial" pitchFamily="34" charset="0"/>
                <a:cs typeface="Arial" pitchFamily="34" charset="0"/>
              </a:rPr>
              <a:t>0.01.</a:t>
            </a:r>
          </a:p>
        </p:txBody>
      </p:sp>
      <p:grpSp>
        <p:nvGrpSpPr>
          <p:cNvPr id="37" name="그룹 36"/>
          <p:cNvGrpSpPr/>
          <p:nvPr/>
        </p:nvGrpSpPr>
        <p:grpSpPr>
          <a:xfrm>
            <a:off x="683848" y="1917160"/>
            <a:ext cx="2520000" cy="2952000"/>
            <a:chOff x="683848" y="1917160"/>
            <a:chExt cx="2520000" cy="2952000"/>
          </a:xfrm>
        </p:grpSpPr>
        <p:cxnSp>
          <p:nvCxnSpPr>
            <p:cNvPr id="6" name="직선 연결선 5"/>
            <p:cNvCxnSpPr/>
            <p:nvPr/>
          </p:nvCxnSpPr>
          <p:spPr>
            <a:xfrm>
              <a:off x="1662204" y="2562576"/>
              <a:ext cx="61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>
              <a:off x="1662204" y="269704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2006178" y="2545654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" name="직선 연결선 9"/>
            <p:cNvCxnSpPr/>
            <p:nvPr/>
          </p:nvCxnSpPr>
          <p:spPr>
            <a:xfrm>
              <a:off x="1654840" y="2544576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/>
            <p:cNvCxnSpPr/>
            <p:nvPr/>
          </p:nvCxnSpPr>
          <p:spPr>
            <a:xfrm>
              <a:off x="2276536" y="2544576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1826178" y="2401638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" name="직선 연결선 15"/>
            <p:cNvCxnSpPr/>
            <p:nvPr/>
          </p:nvCxnSpPr>
          <p:spPr>
            <a:xfrm>
              <a:off x="1654840" y="2677248"/>
              <a:ext cx="0" cy="39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연결선 16"/>
            <p:cNvCxnSpPr/>
            <p:nvPr/>
          </p:nvCxnSpPr>
          <p:spPr>
            <a:xfrm>
              <a:off x="2636576" y="2677248"/>
              <a:ext cx="0" cy="39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7" name="차트 26"/>
            <p:cNvGraphicFramePr/>
            <p:nvPr/>
          </p:nvGraphicFramePr>
          <p:xfrm>
            <a:off x="683848" y="1917160"/>
            <a:ext cx="2520000" cy="295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grpSp>
        <p:nvGrpSpPr>
          <p:cNvPr id="38" name="그룹 37"/>
          <p:cNvGrpSpPr/>
          <p:nvPr/>
        </p:nvGrpSpPr>
        <p:grpSpPr>
          <a:xfrm>
            <a:off x="3420152" y="1916832"/>
            <a:ext cx="2520000" cy="2952000"/>
            <a:chOff x="3420152" y="1916832"/>
            <a:chExt cx="2520000" cy="2952000"/>
          </a:xfrm>
        </p:grpSpPr>
        <p:cxnSp>
          <p:nvCxnSpPr>
            <p:cNvPr id="19" name="직선 연결선 18"/>
            <p:cNvCxnSpPr/>
            <p:nvPr/>
          </p:nvCxnSpPr>
          <p:spPr>
            <a:xfrm>
              <a:off x="4788024" y="2597685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/>
            <p:cNvCxnSpPr/>
            <p:nvPr/>
          </p:nvCxnSpPr>
          <p:spPr>
            <a:xfrm>
              <a:off x="5213921" y="2597685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4788024" y="2617662"/>
              <a:ext cx="432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30" name="차트 29"/>
            <p:cNvGraphicFramePr/>
            <p:nvPr/>
          </p:nvGraphicFramePr>
          <p:xfrm>
            <a:off x="3420152" y="1916832"/>
            <a:ext cx="2520000" cy="295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1" name="TextBox 30"/>
            <p:cNvSpPr txBox="1"/>
            <p:nvPr/>
          </p:nvSpPr>
          <p:spPr>
            <a:xfrm>
              <a:off x="4888907" y="2464021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그룹 38"/>
          <p:cNvGrpSpPr/>
          <p:nvPr/>
        </p:nvGrpSpPr>
        <p:grpSpPr>
          <a:xfrm>
            <a:off x="6072063" y="1916832"/>
            <a:ext cx="2820137" cy="2969445"/>
            <a:chOff x="6072063" y="1916832"/>
            <a:chExt cx="2820137" cy="2969445"/>
          </a:xfrm>
        </p:grpSpPr>
        <p:graphicFrame>
          <p:nvGraphicFramePr>
            <p:cNvPr id="4" name="차트 3"/>
            <p:cNvGraphicFramePr/>
            <p:nvPr>
              <p:extLst>
                <p:ext uri="{D42A27DB-BD31-4B8C-83A1-F6EECF244321}">
                  <p14:modId xmlns:p14="http://schemas.microsoft.com/office/powerpoint/2010/main" val="3956108940"/>
                </p:ext>
              </p:extLst>
            </p:nvPr>
          </p:nvGraphicFramePr>
          <p:xfrm>
            <a:off x="6072063" y="1933689"/>
            <a:ext cx="2773810" cy="29525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22" name="직선 연결선 21"/>
            <p:cNvCxnSpPr/>
            <p:nvPr/>
          </p:nvCxnSpPr>
          <p:spPr>
            <a:xfrm>
              <a:off x="7339080" y="2784690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직선 연결선 22"/>
            <p:cNvCxnSpPr/>
            <p:nvPr/>
          </p:nvCxnSpPr>
          <p:spPr>
            <a:xfrm>
              <a:off x="8142727" y="2784690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/>
            <p:cNvCxnSpPr/>
            <p:nvPr/>
          </p:nvCxnSpPr>
          <p:spPr>
            <a:xfrm>
              <a:off x="7754964" y="2906261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33"/>
            <p:cNvCxnSpPr/>
            <p:nvPr/>
          </p:nvCxnSpPr>
          <p:spPr>
            <a:xfrm>
              <a:off x="8142727" y="2906261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/>
            <p:cNvCxnSpPr/>
            <p:nvPr/>
          </p:nvCxnSpPr>
          <p:spPr>
            <a:xfrm>
              <a:off x="6969470" y="2484352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8142727" y="2484352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/>
            <p:cNvCxnSpPr/>
            <p:nvPr/>
          </p:nvCxnSpPr>
          <p:spPr>
            <a:xfrm>
              <a:off x="7346444" y="2802134"/>
              <a:ext cx="792000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32" name="차트 31"/>
            <p:cNvGraphicFramePr/>
            <p:nvPr/>
          </p:nvGraphicFramePr>
          <p:xfrm>
            <a:off x="6372200" y="1916832"/>
            <a:ext cx="2520000" cy="295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그룹 3"/>
          <p:cNvGrpSpPr>
            <a:grpSpLocks/>
          </p:cNvGrpSpPr>
          <p:nvPr/>
        </p:nvGrpSpPr>
        <p:grpSpPr bwMode="auto">
          <a:xfrm>
            <a:off x="30163" y="590550"/>
            <a:ext cx="4475162" cy="4851400"/>
            <a:chOff x="30193" y="836712"/>
            <a:chExt cx="4475782" cy="4851400"/>
          </a:xfrm>
        </p:grpSpPr>
        <p:grpSp>
          <p:nvGrpSpPr>
            <p:cNvPr id="2064" name="그룹 2"/>
            <p:cNvGrpSpPr>
              <a:grpSpLocks/>
            </p:cNvGrpSpPr>
            <p:nvPr/>
          </p:nvGrpSpPr>
          <p:grpSpPr bwMode="auto">
            <a:xfrm>
              <a:off x="30193" y="836712"/>
              <a:ext cx="4475782" cy="4851400"/>
              <a:chOff x="1176338" y="233363"/>
              <a:chExt cx="6596062" cy="6391275"/>
            </a:xfrm>
          </p:grpSpPr>
          <p:pic>
            <p:nvPicPr>
              <p:cNvPr id="2066" name="Picture 1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71600" y="233363"/>
                <a:ext cx="6400800" cy="63912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2067" name="그룹 3"/>
              <p:cNvGrpSpPr>
                <a:grpSpLocks/>
              </p:cNvGrpSpPr>
              <p:nvPr/>
            </p:nvGrpSpPr>
            <p:grpSpPr bwMode="auto">
              <a:xfrm>
                <a:off x="1176338" y="1400175"/>
                <a:ext cx="6059487" cy="5222875"/>
                <a:chOff x="1176338" y="1400175"/>
                <a:chExt cx="6059487" cy="5222875"/>
              </a:xfrm>
            </p:grpSpPr>
            <p:grpSp>
              <p:nvGrpSpPr>
                <p:cNvPr id="2068" name="그룹 11"/>
                <p:cNvGrpSpPr>
                  <a:grpSpLocks/>
                </p:cNvGrpSpPr>
                <p:nvPr/>
              </p:nvGrpSpPr>
              <p:grpSpPr bwMode="auto">
                <a:xfrm>
                  <a:off x="1176338" y="1400175"/>
                  <a:ext cx="5313806" cy="5222875"/>
                  <a:chOff x="1176189" y="1400175"/>
                  <a:chExt cx="5313926" cy="5222875"/>
                </a:xfrm>
              </p:grpSpPr>
              <p:grpSp>
                <p:nvGrpSpPr>
                  <p:cNvPr id="2071" name="그룹 10"/>
                  <p:cNvGrpSpPr>
                    <a:grpSpLocks/>
                  </p:cNvGrpSpPr>
                  <p:nvPr/>
                </p:nvGrpSpPr>
                <p:grpSpPr bwMode="auto">
                  <a:xfrm>
                    <a:off x="1176189" y="1916832"/>
                    <a:ext cx="4770544" cy="4706218"/>
                    <a:chOff x="1176189" y="1916832"/>
                    <a:chExt cx="4770544" cy="4706218"/>
                  </a:xfrm>
                </p:grpSpPr>
                <p:sp>
                  <p:nvSpPr>
                    <p:cNvPr id="5" name="직사각형 4"/>
                    <p:cNvSpPr/>
                    <p:nvPr/>
                  </p:nvSpPr>
                  <p:spPr bwMode="auto">
                    <a:xfrm>
                      <a:off x="3417824" y="6231458"/>
                      <a:ext cx="2529444" cy="39109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ko-KR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(months)</a:t>
                      </a:r>
                      <a:endParaRPr kumimoji="0" lang="ko-KR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" name="직사각형 5"/>
                    <p:cNvSpPr/>
                    <p:nvPr/>
                  </p:nvSpPr>
                  <p:spPr bwMode="auto">
                    <a:xfrm>
                      <a:off x="1176189" y="1916832"/>
                      <a:ext cx="390821" cy="282218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ko-KR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ability of survival</a:t>
                      </a:r>
                      <a:endParaRPr kumimoji="0" lang="ko-KR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7" name="직사각형 6"/>
                  <p:cNvSpPr/>
                  <p:nvPr/>
                </p:nvSpPr>
                <p:spPr bwMode="auto">
                  <a:xfrm>
                    <a:off x="3637776" y="1400357"/>
                    <a:ext cx="2852352" cy="39318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kumimoji="0" lang="en-US" altLang="ko-KR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AS (+): 61.2±16.0%</a:t>
                    </a:r>
                    <a:endParaRPr kumimoji="0" lang="ko-KR" altLang="en-US" sz="14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1" name="직사각형 10"/>
                <p:cNvSpPr/>
                <p:nvPr/>
              </p:nvSpPr>
              <p:spPr bwMode="auto">
                <a:xfrm>
                  <a:off x="3635529" y="3035821"/>
                  <a:ext cx="2988000" cy="393181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kumimoji="0" lang="en-US" altLang="ko-KR" sz="14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S (-): 62.5±17.1%</a:t>
                  </a:r>
                  <a:endParaRPr kumimoji="0" lang="ko-KR" altLang="en-US" sz="1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직사각형 11"/>
                <p:cNvSpPr/>
                <p:nvPr/>
              </p:nvSpPr>
              <p:spPr bwMode="auto">
                <a:xfrm>
                  <a:off x="5748422" y="5085379"/>
                  <a:ext cx="1488150" cy="393181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kumimoji="0" lang="en-US" altLang="ko-KR" sz="1400" b="1" i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0" lang="en-US" altLang="ko-KR" sz="14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=0.600</a:t>
                  </a:r>
                  <a:endParaRPr kumimoji="0" lang="ko-KR" altLang="en-US" sz="1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" name="직사각형 2"/>
            <p:cNvSpPr/>
            <p:nvPr/>
          </p:nvSpPr>
          <p:spPr>
            <a:xfrm>
              <a:off x="1332123" y="836712"/>
              <a:ext cx="2159299" cy="3603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ko-KR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vent-free survival</a:t>
              </a:r>
              <a:endParaRPr lang="ko-KR" alt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51" name="그룹 7"/>
          <p:cNvGrpSpPr>
            <a:grpSpLocks/>
          </p:cNvGrpSpPr>
          <p:nvPr/>
        </p:nvGrpSpPr>
        <p:grpSpPr bwMode="auto">
          <a:xfrm>
            <a:off x="4716463" y="598488"/>
            <a:ext cx="4354512" cy="4852987"/>
            <a:chOff x="4717142" y="836712"/>
            <a:chExt cx="4354512" cy="4851822"/>
          </a:xfrm>
        </p:grpSpPr>
        <p:grpSp>
          <p:nvGrpSpPr>
            <p:cNvPr id="2053" name="그룹 3"/>
            <p:cNvGrpSpPr>
              <a:grpSpLocks/>
            </p:cNvGrpSpPr>
            <p:nvPr/>
          </p:nvGrpSpPr>
          <p:grpSpPr bwMode="auto">
            <a:xfrm>
              <a:off x="4717142" y="836712"/>
              <a:ext cx="4354512" cy="4851822"/>
              <a:chOff x="1176338" y="233363"/>
              <a:chExt cx="6596062" cy="6391275"/>
            </a:xfrm>
          </p:grpSpPr>
          <p:pic>
            <p:nvPicPr>
              <p:cNvPr id="2055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71600" y="233363"/>
                <a:ext cx="6400800" cy="63912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2056" name="그룹 3"/>
              <p:cNvGrpSpPr>
                <a:grpSpLocks/>
              </p:cNvGrpSpPr>
              <p:nvPr/>
            </p:nvGrpSpPr>
            <p:grpSpPr bwMode="auto">
              <a:xfrm>
                <a:off x="1176338" y="1123950"/>
                <a:ext cx="6059488" cy="5499100"/>
                <a:chOff x="1176338" y="1123950"/>
                <a:chExt cx="6059488" cy="5499100"/>
              </a:xfrm>
            </p:grpSpPr>
            <p:grpSp>
              <p:nvGrpSpPr>
                <p:cNvPr id="2057" name="그룹 11"/>
                <p:cNvGrpSpPr>
                  <a:grpSpLocks/>
                </p:cNvGrpSpPr>
                <p:nvPr/>
              </p:nvGrpSpPr>
              <p:grpSpPr bwMode="auto">
                <a:xfrm>
                  <a:off x="1176338" y="1123950"/>
                  <a:ext cx="6059488" cy="5499100"/>
                  <a:chOff x="1176189" y="1123950"/>
                  <a:chExt cx="6059625" cy="5499100"/>
                </a:xfrm>
              </p:grpSpPr>
              <p:grpSp>
                <p:nvGrpSpPr>
                  <p:cNvPr id="2060" name="그룹 10"/>
                  <p:cNvGrpSpPr>
                    <a:grpSpLocks/>
                  </p:cNvGrpSpPr>
                  <p:nvPr/>
                </p:nvGrpSpPr>
                <p:grpSpPr bwMode="auto">
                  <a:xfrm>
                    <a:off x="1176189" y="1916832"/>
                    <a:ext cx="4770544" cy="4706218"/>
                    <a:chOff x="1176189" y="1916832"/>
                    <a:chExt cx="4770544" cy="4706218"/>
                  </a:xfrm>
                </p:grpSpPr>
                <p:sp>
                  <p:nvSpPr>
                    <p:cNvPr id="21" name="직사각형 20"/>
                    <p:cNvSpPr/>
                    <p:nvPr/>
                  </p:nvSpPr>
                  <p:spPr bwMode="auto">
                    <a:xfrm>
                      <a:off x="3417410" y="6229495"/>
                      <a:ext cx="2529790" cy="39305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ko-KR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(months)</a:t>
                      </a:r>
                      <a:endParaRPr kumimoji="0" lang="ko-KR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" name="직사각형 21"/>
                    <p:cNvSpPr/>
                    <p:nvPr/>
                  </p:nvSpPr>
                  <p:spPr bwMode="auto">
                    <a:xfrm>
                      <a:off x="1176189" y="1916832"/>
                      <a:ext cx="390821" cy="282218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ko-KR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ability of survival</a:t>
                      </a:r>
                      <a:endParaRPr kumimoji="0" lang="ko-KR" alt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0" name="직사각형 19"/>
                  <p:cNvSpPr/>
                  <p:nvPr/>
                </p:nvSpPr>
                <p:spPr bwMode="auto">
                  <a:xfrm>
                    <a:off x="4292737" y="1124001"/>
                    <a:ext cx="2943406" cy="39305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r>
                      <a:rPr kumimoji="0" lang="en-US" altLang="ko-KR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AS (+): 88.2±7.8%</a:t>
                    </a:r>
                    <a:endParaRPr kumimoji="0" lang="ko-KR" altLang="en-US" sz="14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7" name="직사각형 16"/>
                <p:cNvSpPr/>
                <p:nvPr/>
              </p:nvSpPr>
              <p:spPr bwMode="auto">
                <a:xfrm>
                  <a:off x="4401025" y="2420236"/>
                  <a:ext cx="2835129" cy="395142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kumimoji="0" lang="en-US" altLang="ko-KR" sz="14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S (-): 75.0±15.3%</a:t>
                  </a:r>
                  <a:endParaRPr kumimoji="0" lang="ko-KR" altLang="en-US" sz="1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직사각형 17"/>
                <p:cNvSpPr/>
                <p:nvPr/>
              </p:nvSpPr>
              <p:spPr bwMode="auto">
                <a:xfrm>
                  <a:off x="5819792" y="5083790"/>
                  <a:ext cx="1416363" cy="395142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kumimoji="0" lang="en-US" altLang="ko-KR" sz="1400" b="1" i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0" lang="en-US" altLang="ko-KR" sz="14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=0.322</a:t>
                  </a:r>
                  <a:endParaRPr kumimoji="0" lang="ko-KR" altLang="en-US" sz="1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4" name="직사각형 23"/>
            <p:cNvSpPr/>
            <p:nvPr/>
          </p:nvSpPr>
          <p:spPr>
            <a:xfrm>
              <a:off x="5952217" y="850996"/>
              <a:ext cx="2159000" cy="36027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ko-KR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  <a:endParaRPr lang="ko-KR" altLang="en-US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52" name="TextBox 26"/>
          <p:cNvSpPr txBox="1">
            <a:spLocks noChangeArrowheads="1"/>
          </p:cNvSpPr>
          <p:nvPr/>
        </p:nvSpPr>
        <p:spPr bwMode="auto">
          <a:xfrm>
            <a:off x="899592" y="5661248"/>
            <a:ext cx="7632700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r>
              <a:rPr lang="en-US" altLang="ko-KR" sz="1600" dirty="0">
                <a:latin typeface="Arial" charset="0"/>
                <a:ea typeface="굴림" charset="-127"/>
                <a:cs typeface="Arial" charset="0"/>
              </a:rPr>
              <a:t>Supplementary Figure S4. Event-free survival and overall survival of </a:t>
            </a:r>
            <a:r>
              <a:rPr lang="en-US" altLang="ko-KR" sz="1600" i="1" dirty="0">
                <a:latin typeface="Arial" charset="0"/>
                <a:ea typeface="굴림" charset="-127"/>
                <a:cs typeface="Arial" charset="0"/>
              </a:rPr>
              <a:t>BCR-ABL1</a:t>
            </a:r>
            <a:r>
              <a:rPr lang="en-US" altLang="ko-KR" sz="1600" dirty="0">
                <a:latin typeface="Arial" charset="0"/>
                <a:ea typeface="굴림" charset="-127"/>
                <a:cs typeface="Arial" charset="0"/>
              </a:rPr>
              <a:t>-like ALL patients according to RAS pathway mutation status</a:t>
            </a:r>
          </a:p>
        </p:txBody>
      </p:sp>
    </p:spTree>
    <p:extLst>
      <p:ext uri="{BB962C8B-B14F-4D97-AF65-F5344CB8AC3E}">
        <p14:creationId xmlns:p14="http://schemas.microsoft.com/office/powerpoint/2010/main" val="6297058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태양">
      <a:dk1>
        <a:sysClr val="windowText" lastClr="000000"/>
      </a:dk1>
      <a:lt1>
        <a:sysClr val="window" lastClr="FFFFFF"/>
      </a:lt1>
      <a:dk2>
        <a:srgbClr val="4F271C"/>
      </a:dk2>
      <a:lt2>
        <a:srgbClr val="E7DEC9"/>
      </a:lt2>
      <a:accent1>
        <a:srgbClr val="3891A7"/>
      </a:accent1>
      <a:accent2>
        <a:srgbClr val="FEB80A"/>
      </a:accent2>
      <a:accent3>
        <a:srgbClr val="C32D2E"/>
      </a:accent3>
      <a:accent4>
        <a:srgbClr val="84AA33"/>
      </a:accent4>
      <a:accent5>
        <a:srgbClr val="964305"/>
      </a:accent5>
      <a:accent6>
        <a:srgbClr val="475A8D"/>
      </a:accent6>
      <a:hlink>
        <a:srgbClr val="8DC765"/>
      </a:hlink>
      <a:folHlink>
        <a:srgbClr val="AA8A14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9</TotalTime>
  <Words>420</Words>
  <Application>Microsoft Office PowerPoint</Application>
  <PresentationFormat>화면 슬라이드 쇼(4:3)</PresentationFormat>
  <Paragraphs>197</Paragraphs>
  <Slides>5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6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진평</dc:creator>
  <cp:lastModifiedBy>admin</cp:lastModifiedBy>
  <cp:revision>64</cp:revision>
  <cp:lastPrinted>2019-10-15T10:54:40Z</cp:lastPrinted>
  <dcterms:created xsi:type="dcterms:W3CDTF">2019-10-14T14:40:26Z</dcterms:created>
  <dcterms:modified xsi:type="dcterms:W3CDTF">2020-04-14T06:40:23Z</dcterms:modified>
</cp:coreProperties>
</file>